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601200" cy="12801600" type="A3"/>
  <p:notesSz cx="6858000" cy="9144000"/>
  <p:defaultTextStyle>
    <a:defPPr>
      <a:defRPr lang="ja-JP"/>
    </a:defPPr>
    <a:lvl1pPr marL="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35" d="100"/>
          <a:sy n="35" d="100"/>
        </p:scale>
        <p:origin x="1013" y="19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20090" y="3976796"/>
            <a:ext cx="8161020" cy="2744046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5382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211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220652" y="684531"/>
            <a:ext cx="1620203" cy="1456182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60046" y="684531"/>
            <a:ext cx="4700588" cy="1456182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05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7742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2414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60046" y="3982721"/>
            <a:ext cx="3160395" cy="1126363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680461" y="3982721"/>
            <a:ext cx="3160395" cy="1126363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614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0061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877278" y="2865544"/>
            <a:ext cx="4243863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877278" y="4059766"/>
            <a:ext cx="4243863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6326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192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908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1" y="509694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753803" y="509695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80061" y="2678855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5997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881902" y="1143846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881902" y="10019032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288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701EF-296B-4B31-B574-3137FA51B07B}" type="datetimeFigureOut">
              <a:rPr kumimoji="1" lang="ja-JP" altLang="en-US" smtClean="0"/>
              <a:t>2020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677A8-1B0A-42E8-8424-F8D0E66C0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0401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kumimoji="1"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グループ化 36"/>
          <p:cNvGrpSpPr/>
          <p:nvPr/>
        </p:nvGrpSpPr>
        <p:grpSpPr>
          <a:xfrm>
            <a:off x="120080" y="2071028"/>
            <a:ext cx="9433048" cy="10738484"/>
            <a:chOff x="120080" y="2071028"/>
            <a:chExt cx="9433048" cy="10738484"/>
          </a:xfrm>
        </p:grpSpPr>
        <p:graphicFrame>
          <p:nvGraphicFramePr>
            <p:cNvPr id="36" name="オブジェクト 3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52014122"/>
                </p:ext>
              </p:extLst>
            </p:nvPr>
          </p:nvGraphicFramePr>
          <p:xfrm>
            <a:off x="4902121" y="7605605"/>
            <a:ext cx="4651007" cy="3955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6" name="Image" r:id="rId3" imgW="1274760" imgH="1083960" progId="Photoshop.Image.13">
                    <p:embed/>
                  </p:oleObj>
                </mc:Choice>
                <mc:Fallback>
                  <p:oleObj name="Image" r:id="rId3" imgW="1274760" imgH="108396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902121" y="7605605"/>
                          <a:ext cx="4651007" cy="39559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0080" y="2440360"/>
              <a:ext cx="4651007" cy="39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02121" y="2440360"/>
              <a:ext cx="4651007" cy="39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192088" y="2071028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416224" y="2071028"/>
              <a:ext cx="1595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ynaptopodin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6545673" y="2071028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169754" y="3304456"/>
              <a:ext cx="7505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 ADR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720286" y="3130823"/>
              <a:ext cx="56618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ADR+</a:t>
              </a:r>
            </a:p>
            <a:p>
              <a:pPr algn="ctr"/>
              <a:r>
                <a:rPr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axa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4296544" y="2800400"/>
              <a:ext cx="648072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  <a:p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200200" y="3592520"/>
              <a:ext cx="900000" cy="288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844127" y="4199330"/>
              <a:ext cx="7505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 ADR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394659" y="4024536"/>
              <a:ext cx="56618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ADR+</a:t>
              </a:r>
            </a:p>
            <a:p>
              <a:pPr algn="ctr"/>
              <a:r>
                <a:rPr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axa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5880720" y="4456584"/>
              <a:ext cx="900000" cy="288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aphicFrame>
          <p:nvGraphicFramePr>
            <p:cNvPr id="25" name="オブジェクト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0040918"/>
                </p:ext>
              </p:extLst>
            </p:nvPr>
          </p:nvGraphicFramePr>
          <p:xfrm>
            <a:off x="149593" y="7625336"/>
            <a:ext cx="4651007" cy="39550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7" name="Image" r:id="rId7" imgW="6196680" imgH="5269680" progId="Photoshop.Image.13">
                    <p:embed/>
                  </p:oleObj>
                </mc:Choice>
                <mc:Fallback>
                  <p:oleObj name="Image" r:id="rId7" imgW="6196680" imgH="526968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49593" y="7625336"/>
                          <a:ext cx="4651007" cy="39550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テキスト ボックス 10"/>
            <p:cNvSpPr txBox="1"/>
            <p:nvPr/>
          </p:nvSpPr>
          <p:spPr>
            <a:xfrm>
              <a:off x="1974411" y="7291898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RhoA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6617681" y="7291898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92088" y="7264896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2280320" y="9425136"/>
              <a:ext cx="7505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 ADR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850237" y="9251503"/>
              <a:ext cx="56618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ADR+</a:t>
              </a:r>
            </a:p>
            <a:p>
              <a:pPr algn="ctr"/>
              <a:r>
                <a:rPr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axa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224536" y="7992521"/>
              <a:ext cx="648072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  <a:p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2352328" y="10001200"/>
              <a:ext cx="900000" cy="288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7002402" y="9383906"/>
              <a:ext cx="7505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 ADR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7536904" y="9209112"/>
              <a:ext cx="56618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ADR+</a:t>
              </a:r>
            </a:p>
            <a:p>
              <a:pPr algn="ctr"/>
              <a:r>
                <a:rPr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axa</a:t>
              </a:r>
              <a:endParaRPr lang="en-US" altLang="ja-JP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7068952" y="9641192"/>
              <a:ext cx="900000" cy="288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20080" y="12470958"/>
              <a:ext cx="16401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Additional File 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42873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</TotalTime>
  <Words>56</Words>
  <Application>Microsoft Office PowerPoint</Application>
  <PresentationFormat>A3 297x420 mm</PresentationFormat>
  <Paragraphs>4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Office ​​テーマ</vt:lpstr>
      <vt:lpstr>Imag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yano</dc:creator>
  <cp:lastModifiedBy>Hitoshi</cp:lastModifiedBy>
  <cp:revision>14</cp:revision>
  <dcterms:created xsi:type="dcterms:W3CDTF">2020-08-10T03:22:50Z</dcterms:created>
  <dcterms:modified xsi:type="dcterms:W3CDTF">2020-09-06T00:11:04Z</dcterms:modified>
</cp:coreProperties>
</file>